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1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2013123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2013123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2013123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2013123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20131230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2013123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3571741032371"/>
          <c:y val="0.0282524059492563"/>
          <c:w val="0.657393482064742"/>
          <c:h val="0.79822506561679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PLASMA!$A$82</c:f>
              <c:strCache>
                <c:ptCount val="1"/>
                <c:pt idx="0">
                  <c:v>A给药组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LASMA!$D$83:$D$88</c:f>
                <c:numCache>
                  <c:formatCode>General</c:formatCode>
                  <c:ptCount val="6"/>
                  <c:pt idx="0">
                    <c:v>15.47402178928312</c:v>
                  </c:pt>
                  <c:pt idx="1">
                    <c:v>17.74333275418018</c:v>
                  </c:pt>
                  <c:pt idx="2">
                    <c:v>7.68258308298207</c:v>
                  </c:pt>
                  <c:pt idx="3">
                    <c:v>11.0320312832165</c:v>
                  </c:pt>
                  <c:pt idx="4">
                    <c:v>3.50455481860601</c:v>
                  </c:pt>
                  <c:pt idx="5">
                    <c:v>0.213550405750889</c:v>
                  </c:pt>
                </c:numCache>
              </c:numRef>
            </c:plus>
            <c:minus>
              <c:numRef>
                <c:f>PLASMA!$D$83:$D$88</c:f>
                <c:numCache>
                  <c:formatCode>General</c:formatCode>
                  <c:ptCount val="6"/>
                  <c:pt idx="0">
                    <c:v>15.47402178928312</c:v>
                  </c:pt>
                  <c:pt idx="1">
                    <c:v>17.74333275418018</c:v>
                  </c:pt>
                  <c:pt idx="2">
                    <c:v>7.68258308298207</c:v>
                  </c:pt>
                  <c:pt idx="3">
                    <c:v>11.0320312832165</c:v>
                  </c:pt>
                  <c:pt idx="4">
                    <c:v>3.50455481860601</c:v>
                  </c:pt>
                  <c:pt idx="5">
                    <c:v>0.213550405750889</c:v>
                  </c:pt>
                </c:numCache>
              </c:numRef>
            </c:minus>
          </c:errBars>
          <c:xVal>
            <c:numRef>
              <c:f>PLASMA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PLASMA!$C$83:$C$88</c:f>
              <c:numCache>
                <c:formatCode>General</c:formatCode>
                <c:ptCount val="6"/>
                <c:pt idx="0">
                  <c:v>53.69843614300254</c:v>
                </c:pt>
                <c:pt idx="1">
                  <c:v>58.16403483489623</c:v>
                </c:pt>
                <c:pt idx="2">
                  <c:v>38.3922151306059</c:v>
                </c:pt>
                <c:pt idx="3">
                  <c:v>20.48989958844717</c:v>
                </c:pt>
                <c:pt idx="4">
                  <c:v>6.199548757960238</c:v>
                </c:pt>
                <c:pt idx="5">
                  <c:v>0.28698883676286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PLASMA!$A$95</c:f>
              <c:strCache>
                <c:ptCount val="1"/>
                <c:pt idx="0">
                  <c:v>S给药组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LASMA!$D$89:$D$94</c:f>
                <c:numCache>
                  <c:formatCode>General</c:formatCode>
                  <c:ptCount val="6"/>
                  <c:pt idx="0">
                    <c:v>37.291207728895</c:v>
                  </c:pt>
                  <c:pt idx="1">
                    <c:v>28.14803359074588</c:v>
                  </c:pt>
                  <c:pt idx="2">
                    <c:v>45.46284004311392</c:v>
                  </c:pt>
                  <c:pt idx="3">
                    <c:v>19.9970574474264</c:v>
                  </c:pt>
                  <c:pt idx="4">
                    <c:v>27.28640464508159</c:v>
                  </c:pt>
                  <c:pt idx="5">
                    <c:v>0.200234970161361</c:v>
                  </c:pt>
                </c:numCache>
              </c:numRef>
            </c:plus>
            <c:minus>
              <c:numRef>
                <c:f>PLASMA!$D$89:$D$94</c:f>
                <c:numCache>
                  <c:formatCode>General</c:formatCode>
                  <c:ptCount val="6"/>
                  <c:pt idx="0">
                    <c:v>37.291207728895</c:v>
                  </c:pt>
                  <c:pt idx="1">
                    <c:v>28.14803359074588</c:v>
                  </c:pt>
                  <c:pt idx="2">
                    <c:v>45.46284004311392</c:v>
                  </c:pt>
                  <c:pt idx="3">
                    <c:v>19.9970574474264</c:v>
                  </c:pt>
                  <c:pt idx="4">
                    <c:v>27.28640464508159</c:v>
                  </c:pt>
                  <c:pt idx="5">
                    <c:v>0.200234970161361</c:v>
                  </c:pt>
                </c:numCache>
              </c:numRef>
            </c:minus>
          </c:errBars>
          <c:xVal>
            <c:numRef>
              <c:f>PLASMA!$B$89:$B$94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PLASMA!$C$89:$C$94</c:f>
              <c:numCache>
                <c:formatCode>General</c:formatCode>
                <c:ptCount val="6"/>
                <c:pt idx="0">
                  <c:v>225.5800766592483</c:v>
                </c:pt>
                <c:pt idx="1">
                  <c:v>166.8892266758187</c:v>
                </c:pt>
                <c:pt idx="2">
                  <c:v>126.4523010243948</c:v>
                </c:pt>
                <c:pt idx="3">
                  <c:v>92.8662394557186</c:v>
                </c:pt>
                <c:pt idx="4">
                  <c:v>38.12746319023854</c:v>
                </c:pt>
                <c:pt idx="5">
                  <c:v>1.98737664025964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1840248"/>
        <c:axId val="-2085498008"/>
      </c:scatterChart>
      <c:valAx>
        <c:axId val="1821840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5498008"/>
        <c:crosses val="autoZero"/>
        <c:crossBetween val="midCat"/>
      </c:valAx>
      <c:valAx>
        <c:axId val="-2085498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182184024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KIDNEY!$A$82</c:f>
              <c:strCache>
                <c:ptCount val="1"/>
                <c:pt idx="0">
                  <c:v>A给药组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heart!$D$83:$D$88</c:f>
                <c:numCache>
                  <c:formatCode>General</c:formatCode>
                  <c:ptCount val="6"/>
                  <c:pt idx="0">
                    <c:v>1.26936394013592</c:v>
                  </c:pt>
                  <c:pt idx="1">
                    <c:v>1.004431565041852</c:v>
                  </c:pt>
                  <c:pt idx="2">
                    <c:v>1.066984085181701</c:v>
                  </c:pt>
                  <c:pt idx="3">
                    <c:v>0.930133573472434</c:v>
                  </c:pt>
                  <c:pt idx="4">
                    <c:v>0.533321774342714</c:v>
                  </c:pt>
                  <c:pt idx="5">
                    <c:v>0.075533042807799</c:v>
                  </c:pt>
                </c:numCache>
              </c:numRef>
            </c:plus>
            <c:minus>
              <c:numRef>
                <c:f>heart!$D$83:$D$88</c:f>
                <c:numCache>
                  <c:formatCode>General</c:formatCode>
                  <c:ptCount val="6"/>
                  <c:pt idx="0">
                    <c:v>1.26936394013592</c:v>
                  </c:pt>
                  <c:pt idx="1">
                    <c:v>1.004431565041852</c:v>
                  </c:pt>
                  <c:pt idx="2">
                    <c:v>1.066984085181701</c:v>
                  </c:pt>
                  <c:pt idx="3">
                    <c:v>0.930133573472434</c:v>
                  </c:pt>
                  <c:pt idx="4">
                    <c:v>0.533321774342714</c:v>
                  </c:pt>
                  <c:pt idx="5">
                    <c:v>0.075533042807799</c:v>
                  </c:pt>
                </c:numCache>
              </c:numRef>
            </c:minus>
          </c:errBars>
          <c:xVal>
            <c:numRef>
              <c:f>KIDNEY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heart!$C$83:$C$88</c:f>
              <c:numCache>
                <c:formatCode>General</c:formatCode>
                <c:ptCount val="6"/>
                <c:pt idx="0">
                  <c:v>6.666882055017154</c:v>
                </c:pt>
                <c:pt idx="1">
                  <c:v>6.27059397455345</c:v>
                </c:pt>
                <c:pt idx="2">
                  <c:v>5.55675878056063</c:v>
                </c:pt>
                <c:pt idx="3">
                  <c:v>4.105318173448087</c:v>
                </c:pt>
                <c:pt idx="4">
                  <c:v>1.126570284057123</c:v>
                </c:pt>
                <c:pt idx="5">
                  <c:v>0.0496329762092088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KIDNEY!$A$95</c:f>
              <c:strCache>
                <c:ptCount val="1"/>
                <c:pt idx="0">
                  <c:v>S给药组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heart!$D$89:$D$94</c:f>
                <c:numCache>
                  <c:formatCode>General</c:formatCode>
                  <c:ptCount val="6"/>
                  <c:pt idx="0">
                    <c:v>20.13451589645516</c:v>
                  </c:pt>
                  <c:pt idx="1">
                    <c:v>6.045480882365633</c:v>
                  </c:pt>
                  <c:pt idx="2">
                    <c:v>8.284748988130392</c:v>
                  </c:pt>
                  <c:pt idx="3">
                    <c:v>3.122714553820921</c:v>
                  </c:pt>
                  <c:pt idx="4">
                    <c:v>4.619931481779756</c:v>
                  </c:pt>
                  <c:pt idx="5">
                    <c:v>1.8733920681637</c:v>
                  </c:pt>
                </c:numCache>
              </c:numRef>
            </c:plus>
            <c:minus>
              <c:numRef>
                <c:f>heart!$D$89:$D$94</c:f>
                <c:numCache>
                  <c:formatCode>General</c:formatCode>
                  <c:ptCount val="6"/>
                  <c:pt idx="0">
                    <c:v>20.13451589645516</c:v>
                  </c:pt>
                  <c:pt idx="1">
                    <c:v>6.045480882365633</c:v>
                  </c:pt>
                  <c:pt idx="2">
                    <c:v>8.284748988130392</c:v>
                  </c:pt>
                  <c:pt idx="3">
                    <c:v>3.122714553820921</c:v>
                  </c:pt>
                  <c:pt idx="4">
                    <c:v>4.619931481779756</c:v>
                  </c:pt>
                  <c:pt idx="5">
                    <c:v>1.8733920681637</c:v>
                  </c:pt>
                </c:numCache>
              </c:numRef>
            </c:minus>
          </c:errBars>
          <c:xVal>
            <c:numRef>
              <c:f>KIDNEY!$B$89:$B$94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heart!$C$89:$C$94</c:f>
              <c:numCache>
                <c:formatCode>General</c:formatCode>
                <c:ptCount val="6"/>
                <c:pt idx="0">
                  <c:v>50.44890598870905</c:v>
                </c:pt>
                <c:pt idx="1">
                  <c:v>31.30210534148796</c:v>
                </c:pt>
                <c:pt idx="2">
                  <c:v>27.70490563327348</c:v>
                </c:pt>
                <c:pt idx="3">
                  <c:v>17.11840650011407</c:v>
                </c:pt>
                <c:pt idx="4">
                  <c:v>7.606612520288285</c:v>
                </c:pt>
                <c:pt idx="5">
                  <c:v>1.82588335657884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1971336"/>
        <c:axId val="-2083780632"/>
      </c:scatterChart>
      <c:valAx>
        <c:axId val="-2041971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3780632"/>
        <c:crosses val="autoZero"/>
        <c:crossBetween val="midCat"/>
      </c:valAx>
      <c:valAx>
        <c:axId val="-2083780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4197133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LIVER!$A$82</c:f>
              <c:strCache>
                <c:ptCount val="1"/>
                <c:pt idx="0">
                  <c:v>A给药组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LIVER!$D$83:$D$88</c:f>
                <c:numCache>
                  <c:formatCode>General</c:formatCode>
                  <c:ptCount val="6"/>
                  <c:pt idx="0">
                    <c:v>12.30200636113711</c:v>
                  </c:pt>
                  <c:pt idx="1">
                    <c:v>9.293600804038725</c:v>
                  </c:pt>
                  <c:pt idx="2">
                    <c:v>6.666816062912685</c:v>
                  </c:pt>
                  <c:pt idx="3">
                    <c:v>5.10483386309456</c:v>
                  </c:pt>
                  <c:pt idx="4">
                    <c:v>3.511711076747083</c:v>
                  </c:pt>
                  <c:pt idx="5">
                    <c:v>1.394462425493834</c:v>
                  </c:pt>
                </c:numCache>
              </c:numRef>
            </c:plus>
            <c:minus>
              <c:numRef>
                <c:f>LIVER!$D$83:$D$88</c:f>
                <c:numCache>
                  <c:formatCode>General</c:formatCode>
                  <c:ptCount val="6"/>
                  <c:pt idx="0">
                    <c:v>12.30200636113711</c:v>
                  </c:pt>
                  <c:pt idx="1">
                    <c:v>9.293600804038725</c:v>
                  </c:pt>
                  <c:pt idx="2">
                    <c:v>6.666816062912685</c:v>
                  </c:pt>
                  <c:pt idx="3">
                    <c:v>5.10483386309456</c:v>
                  </c:pt>
                  <c:pt idx="4">
                    <c:v>3.511711076747083</c:v>
                  </c:pt>
                  <c:pt idx="5">
                    <c:v>1.394462425493834</c:v>
                  </c:pt>
                </c:numCache>
              </c:numRef>
            </c:minus>
          </c:errBars>
          <c:xVal>
            <c:numRef>
              <c:f>LIVER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LIVER!$C$83:$C$88</c:f>
              <c:numCache>
                <c:formatCode>General</c:formatCode>
                <c:ptCount val="6"/>
                <c:pt idx="0">
                  <c:v>59.86058179132164</c:v>
                </c:pt>
                <c:pt idx="1">
                  <c:v>52.89983198793385</c:v>
                </c:pt>
                <c:pt idx="2">
                  <c:v>32.7759163087249</c:v>
                </c:pt>
                <c:pt idx="3">
                  <c:v>19.54720846753742</c:v>
                </c:pt>
                <c:pt idx="4">
                  <c:v>5.322079445788098</c:v>
                </c:pt>
                <c:pt idx="5">
                  <c:v>1.65760168746485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LIVER!$A$95</c:f>
              <c:strCache>
                <c:ptCount val="1"/>
                <c:pt idx="0">
                  <c:v>S给药组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LIVER!$D$89:$D$94</c:f>
                <c:numCache>
                  <c:formatCode>General</c:formatCode>
                  <c:ptCount val="6"/>
                  <c:pt idx="0">
                    <c:v>11.40843111920327</c:v>
                  </c:pt>
                  <c:pt idx="1">
                    <c:v>21.02166931118719</c:v>
                  </c:pt>
                  <c:pt idx="2">
                    <c:v>15.14947582701379</c:v>
                  </c:pt>
                  <c:pt idx="3">
                    <c:v>15.55626128758658</c:v>
                  </c:pt>
                  <c:pt idx="4">
                    <c:v>9.888624142776891</c:v>
                  </c:pt>
                  <c:pt idx="5">
                    <c:v>4.28419401031254</c:v>
                  </c:pt>
                </c:numCache>
              </c:numRef>
            </c:plus>
            <c:minus>
              <c:numRef>
                <c:f>LIVER!$D$89:$D$94</c:f>
                <c:numCache>
                  <c:formatCode>General</c:formatCode>
                  <c:ptCount val="6"/>
                  <c:pt idx="0">
                    <c:v>11.40843111920327</c:v>
                  </c:pt>
                  <c:pt idx="1">
                    <c:v>21.02166931118719</c:v>
                  </c:pt>
                  <c:pt idx="2">
                    <c:v>15.14947582701379</c:v>
                  </c:pt>
                  <c:pt idx="3">
                    <c:v>15.55626128758658</c:v>
                  </c:pt>
                  <c:pt idx="4">
                    <c:v>9.888624142776891</c:v>
                  </c:pt>
                  <c:pt idx="5">
                    <c:v>4.28419401031254</c:v>
                  </c:pt>
                </c:numCache>
              </c:numRef>
            </c:minus>
          </c:errBars>
          <c:xVal>
            <c:numRef>
              <c:f>LIVER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LIVER!$C$89:$C$94</c:f>
              <c:numCache>
                <c:formatCode>General</c:formatCode>
                <c:ptCount val="6"/>
                <c:pt idx="0">
                  <c:v>109.1847814311725</c:v>
                </c:pt>
                <c:pt idx="1">
                  <c:v>107.5221436277674</c:v>
                </c:pt>
                <c:pt idx="2">
                  <c:v>94.12880351898202</c:v>
                </c:pt>
                <c:pt idx="3">
                  <c:v>51.11463873689773</c:v>
                </c:pt>
                <c:pt idx="4">
                  <c:v>20.57390549236568</c:v>
                </c:pt>
                <c:pt idx="5">
                  <c:v>5.45078500714466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4842824"/>
        <c:axId val="-2084883224"/>
      </c:scatterChart>
      <c:valAx>
        <c:axId val="-2084842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4883224"/>
        <c:crosses val="autoZero"/>
        <c:crossBetween val="midCat"/>
      </c:valAx>
      <c:valAx>
        <c:axId val="-2084883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484282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KIDNEY!$A$82</c:f>
              <c:strCache>
                <c:ptCount val="1"/>
                <c:pt idx="0">
                  <c:v>A给药组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pleen!$D$83:$D$88</c:f>
                <c:numCache>
                  <c:formatCode>General</c:formatCode>
                  <c:ptCount val="6"/>
                  <c:pt idx="0">
                    <c:v>3.319008813470456</c:v>
                  </c:pt>
                  <c:pt idx="1">
                    <c:v>3.522484227779554</c:v>
                  </c:pt>
                  <c:pt idx="2">
                    <c:v>9.31778521855393</c:v>
                  </c:pt>
                  <c:pt idx="3">
                    <c:v>5.38889705754339</c:v>
                  </c:pt>
                  <c:pt idx="4">
                    <c:v>1.88854074370173</c:v>
                  </c:pt>
                  <c:pt idx="5">
                    <c:v>0.390462021006964</c:v>
                  </c:pt>
                </c:numCache>
              </c:numRef>
            </c:plus>
            <c:minus>
              <c:numRef>
                <c:f>spleen!$D$83:$D$88</c:f>
                <c:numCache>
                  <c:formatCode>General</c:formatCode>
                  <c:ptCount val="6"/>
                  <c:pt idx="0">
                    <c:v>3.319008813470456</c:v>
                  </c:pt>
                  <c:pt idx="1">
                    <c:v>3.522484227779554</c:v>
                  </c:pt>
                  <c:pt idx="2">
                    <c:v>9.31778521855393</c:v>
                  </c:pt>
                  <c:pt idx="3">
                    <c:v>5.38889705754339</c:v>
                  </c:pt>
                  <c:pt idx="4">
                    <c:v>1.88854074370173</c:v>
                  </c:pt>
                  <c:pt idx="5">
                    <c:v>0.390462021006964</c:v>
                  </c:pt>
                </c:numCache>
              </c:numRef>
            </c:minus>
          </c:errBars>
          <c:xVal>
            <c:numRef>
              <c:f>KIDNEY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spleen!$C$83:$C$88</c:f>
              <c:numCache>
                <c:formatCode>General</c:formatCode>
                <c:ptCount val="6"/>
                <c:pt idx="0">
                  <c:v>7.365760355966612</c:v>
                </c:pt>
                <c:pt idx="1">
                  <c:v>11.5245933544357</c:v>
                </c:pt>
                <c:pt idx="2">
                  <c:v>24.09469756651885</c:v>
                </c:pt>
                <c:pt idx="3">
                  <c:v>22.78624923239799</c:v>
                </c:pt>
                <c:pt idx="4">
                  <c:v>7.537300946981436</c:v>
                </c:pt>
                <c:pt idx="5">
                  <c:v>0.63333147989036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KIDNEY!$A$95</c:f>
              <c:strCache>
                <c:ptCount val="1"/>
                <c:pt idx="0">
                  <c:v>S给药组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pleen!$D$89:$D$94</c:f>
                <c:numCache>
                  <c:formatCode>General</c:formatCode>
                  <c:ptCount val="6"/>
                  <c:pt idx="0">
                    <c:v>3.047923600440893</c:v>
                  </c:pt>
                  <c:pt idx="1">
                    <c:v>14.0145585266154</c:v>
                  </c:pt>
                  <c:pt idx="2">
                    <c:v>7.256331568084486</c:v>
                  </c:pt>
                  <c:pt idx="3">
                    <c:v>12.21657078338395</c:v>
                  </c:pt>
                  <c:pt idx="4">
                    <c:v>19.20517576671056</c:v>
                  </c:pt>
                  <c:pt idx="5">
                    <c:v>2.409618076770163</c:v>
                  </c:pt>
                </c:numCache>
              </c:numRef>
            </c:plus>
            <c:minus>
              <c:numRef>
                <c:f>spleen!$D$89:$D$94</c:f>
                <c:numCache>
                  <c:formatCode>General</c:formatCode>
                  <c:ptCount val="6"/>
                  <c:pt idx="0">
                    <c:v>3.047923600440893</c:v>
                  </c:pt>
                  <c:pt idx="1">
                    <c:v>14.0145585266154</c:v>
                  </c:pt>
                  <c:pt idx="2">
                    <c:v>7.256331568084486</c:v>
                  </c:pt>
                  <c:pt idx="3">
                    <c:v>12.21657078338395</c:v>
                  </c:pt>
                  <c:pt idx="4">
                    <c:v>19.20517576671056</c:v>
                  </c:pt>
                  <c:pt idx="5">
                    <c:v>2.409618076770163</c:v>
                  </c:pt>
                </c:numCache>
              </c:numRef>
            </c:minus>
          </c:errBars>
          <c:xVal>
            <c:numRef>
              <c:f>KIDNEY!$B$89:$B$94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spleen!$C$89:$C$94</c:f>
              <c:numCache>
                <c:formatCode>General</c:formatCode>
                <c:ptCount val="6"/>
                <c:pt idx="0">
                  <c:v>30.00821076149055</c:v>
                </c:pt>
                <c:pt idx="1">
                  <c:v>55.89360328822045</c:v>
                </c:pt>
                <c:pt idx="2">
                  <c:v>65.56702977189932</c:v>
                </c:pt>
                <c:pt idx="3">
                  <c:v>75.33560657664778</c:v>
                </c:pt>
                <c:pt idx="4">
                  <c:v>44.88466812816809</c:v>
                </c:pt>
                <c:pt idx="5">
                  <c:v>4.32494488923813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3706104"/>
        <c:axId val="-2042532296"/>
      </c:scatterChart>
      <c:valAx>
        <c:axId val="-2083706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42532296"/>
        <c:crosses val="autoZero"/>
        <c:crossBetween val="midCat"/>
      </c:valAx>
      <c:valAx>
        <c:axId val="-2042532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370610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KIDNEY!$A$82</c:f>
              <c:strCache>
                <c:ptCount val="1"/>
                <c:pt idx="0">
                  <c:v>A给药组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KIDNEY!$D$83:$D$88</c:f>
                <c:numCache>
                  <c:formatCode>General</c:formatCode>
                  <c:ptCount val="6"/>
                  <c:pt idx="0">
                    <c:v>4.346183086995055</c:v>
                  </c:pt>
                  <c:pt idx="1">
                    <c:v>1.98069232939034</c:v>
                  </c:pt>
                  <c:pt idx="2">
                    <c:v>3.89431953585716</c:v>
                  </c:pt>
                  <c:pt idx="3">
                    <c:v>3.099097172577946</c:v>
                  </c:pt>
                  <c:pt idx="4">
                    <c:v>1.813209215568062</c:v>
                  </c:pt>
                  <c:pt idx="5">
                    <c:v>0.191741546006376</c:v>
                  </c:pt>
                </c:numCache>
              </c:numRef>
            </c:plus>
            <c:minus>
              <c:numRef>
                <c:f>KIDNEY!$D$83:$D$88</c:f>
                <c:numCache>
                  <c:formatCode>General</c:formatCode>
                  <c:ptCount val="6"/>
                  <c:pt idx="0">
                    <c:v>4.346183086995055</c:v>
                  </c:pt>
                  <c:pt idx="1">
                    <c:v>1.98069232939034</c:v>
                  </c:pt>
                  <c:pt idx="2">
                    <c:v>3.89431953585716</c:v>
                  </c:pt>
                  <c:pt idx="3">
                    <c:v>3.099097172577946</c:v>
                  </c:pt>
                  <c:pt idx="4">
                    <c:v>1.813209215568062</c:v>
                  </c:pt>
                  <c:pt idx="5">
                    <c:v>0.191741546006376</c:v>
                  </c:pt>
                </c:numCache>
              </c:numRef>
            </c:minus>
          </c:errBars>
          <c:xVal>
            <c:numRef>
              <c:f>KIDNEY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F!$C$83:$C$88</c:f>
              <c:numCache>
                <c:formatCode>General</c:formatCode>
                <c:ptCount val="6"/>
                <c:pt idx="0">
                  <c:v>18.97931211969082</c:v>
                </c:pt>
                <c:pt idx="1">
                  <c:v>29.42363150184146</c:v>
                </c:pt>
                <c:pt idx="2">
                  <c:v>35.93956950660244</c:v>
                </c:pt>
                <c:pt idx="3">
                  <c:v>29.84793648011155</c:v>
                </c:pt>
                <c:pt idx="4">
                  <c:v>8.01312965258099</c:v>
                </c:pt>
                <c:pt idx="5">
                  <c:v>1.0401844391599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KIDNEY!$A$95</c:f>
              <c:strCache>
                <c:ptCount val="1"/>
                <c:pt idx="0">
                  <c:v>S给药组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!$D$89:$D$94</c:f>
                <c:numCache>
                  <c:formatCode>General</c:formatCode>
                  <c:ptCount val="6"/>
                  <c:pt idx="0">
                    <c:v>41.44170520399486</c:v>
                  </c:pt>
                  <c:pt idx="1">
                    <c:v>70.08270722604367</c:v>
                  </c:pt>
                  <c:pt idx="2">
                    <c:v>34.39006541263245</c:v>
                  </c:pt>
                  <c:pt idx="3">
                    <c:v>23.44173010613109</c:v>
                  </c:pt>
                  <c:pt idx="4">
                    <c:v>21.6613682238488</c:v>
                  </c:pt>
                  <c:pt idx="5">
                    <c:v>0.314964143238902</c:v>
                  </c:pt>
                </c:numCache>
              </c:numRef>
            </c:plus>
            <c:minus>
              <c:numRef>
                <c:f>F!$D$89:$D$94</c:f>
                <c:numCache>
                  <c:formatCode>General</c:formatCode>
                  <c:ptCount val="6"/>
                  <c:pt idx="0">
                    <c:v>41.44170520399486</c:v>
                  </c:pt>
                  <c:pt idx="1">
                    <c:v>70.08270722604367</c:v>
                  </c:pt>
                  <c:pt idx="2">
                    <c:v>34.39006541263245</c:v>
                  </c:pt>
                  <c:pt idx="3">
                    <c:v>23.44173010613109</c:v>
                  </c:pt>
                  <c:pt idx="4">
                    <c:v>21.6613682238488</c:v>
                  </c:pt>
                  <c:pt idx="5">
                    <c:v>0.314964143238902</c:v>
                  </c:pt>
                </c:numCache>
              </c:numRef>
            </c:minus>
          </c:errBars>
          <c:xVal>
            <c:numRef>
              <c:f>KIDNEY!$B$89:$B$94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F!$C$89:$C$94</c:f>
              <c:numCache>
                <c:formatCode>General</c:formatCode>
                <c:ptCount val="6"/>
                <c:pt idx="0">
                  <c:v>210.019249935428</c:v>
                </c:pt>
                <c:pt idx="1">
                  <c:v>188.3544386154613</c:v>
                </c:pt>
                <c:pt idx="2">
                  <c:v>171.0243102292453</c:v>
                </c:pt>
                <c:pt idx="3">
                  <c:v>104.8184755222912</c:v>
                </c:pt>
                <c:pt idx="4">
                  <c:v>47.69613200022673</c:v>
                </c:pt>
                <c:pt idx="5">
                  <c:v>4.7038990255086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4047208"/>
        <c:axId val="-2085573896"/>
      </c:scatterChart>
      <c:valAx>
        <c:axId val="-2084047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5573896"/>
        <c:crosses val="autoZero"/>
        <c:crossBetween val="midCat"/>
      </c:valAx>
      <c:valAx>
        <c:axId val="-2085573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40472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3577953164728"/>
          <c:y val="0.0319083763296186"/>
          <c:w val="0.791705267631946"/>
          <c:h val="0.77211461028320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KIDNEY!$A$82</c:f>
              <c:strCache>
                <c:ptCount val="1"/>
                <c:pt idx="0">
                  <c:v>A给药组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KIDNEY!$D$83:$D$88</c:f>
                <c:numCache>
                  <c:formatCode>General</c:formatCode>
                  <c:ptCount val="6"/>
                  <c:pt idx="0">
                    <c:v>4.346183086995055</c:v>
                  </c:pt>
                  <c:pt idx="1">
                    <c:v>1.98069232939034</c:v>
                  </c:pt>
                  <c:pt idx="2">
                    <c:v>3.89431953585716</c:v>
                  </c:pt>
                  <c:pt idx="3">
                    <c:v>3.099097172577946</c:v>
                  </c:pt>
                  <c:pt idx="4">
                    <c:v>1.813209215568062</c:v>
                  </c:pt>
                  <c:pt idx="5">
                    <c:v>0.191741546006376</c:v>
                  </c:pt>
                </c:numCache>
              </c:numRef>
            </c:plus>
            <c:minus>
              <c:numRef>
                <c:f>KIDNEY!$D$83:$D$88</c:f>
                <c:numCache>
                  <c:formatCode>General</c:formatCode>
                  <c:ptCount val="6"/>
                  <c:pt idx="0">
                    <c:v>4.346183086995055</c:v>
                  </c:pt>
                  <c:pt idx="1">
                    <c:v>1.98069232939034</c:v>
                  </c:pt>
                  <c:pt idx="2">
                    <c:v>3.89431953585716</c:v>
                  </c:pt>
                  <c:pt idx="3">
                    <c:v>3.099097172577946</c:v>
                  </c:pt>
                  <c:pt idx="4">
                    <c:v>1.813209215568062</c:v>
                  </c:pt>
                  <c:pt idx="5">
                    <c:v>0.191741546006376</c:v>
                  </c:pt>
                </c:numCache>
              </c:numRef>
            </c:minus>
          </c:errBars>
          <c:xVal>
            <c:numRef>
              <c:f>KIDNEY!$B$83:$B$88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KIDNEY!$C$83:$C$88</c:f>
              <c:numCache>
                <c:formatCode>General</c:formatCode>
                <c:ptCount val="6"/>
                <c:pt idx="0">
                  <c:v>11.45899866110073</c:v>
                </c:pt>
                <c:pt idx="1">
                  <c:v>15.16414971011337</c:v>
                </c:pt>
                <c:pt idx="2">
                  <c:v>20.14144268435221</c:v>
                </c:pt>
                <c:pt idx="3">
                  <c:v>16.59495423053483</c:v>
                </c:pt>
                <c:pt idx="4">
                  <c:v>4.79756367940984</c:v>
                </c:pt>
                <c:pt idx="5">
                  <c:v>0.192987838343538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KIDNEY!$A$95</c:f>
              <c:strCache>
                <c:ptCount val="1"/>
                <c:pt idx="0">
                  <c:v>S给药组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KIDNEY!$D$89:$D$94</c:f>
                <c:numCache>
                  <c:formatCode>General</c:formatCode>
                  <c:ptCount val="6"/>
                  <c:pt idx="0">
                    <c:v>9.173672620972318</c:v>
                  </c:pt>
                  <c:pt idx="1">
                    <c:v>8.493131344815881</c:v>
                  </c:pt>
                  <c:pt idx="2">
                    <c:v>14.39360996091442</c:v>
                  </c:pt>
                  <c:pt idx="3">
                    <c:v>11.47025221074641</c:v>
                  </c:pt>
                  <c:pt idx="4">
                    <c:v>8.431870490434218</c:v>
                  </c:pt>
                  <c:pt idx="5">
                    <c:v>0.567894273258425</c:v>
                  </c:pt>
                </c:numCache>
              </c:numRef>
            </c:plus>
            <c:minus>
              <c:numRef>
                <c:f>KIDNEY!$D$89:$D$94</c:f>
                <c:numCache>
                  <c:formatCode>General</c:formatCode>
                  <c:ptCount val="6"/>
                  <c:pt idx="0">
                    <c:v>9.173672620972318</c:v>
                  </c:pt>
                  <c:pt idx="1">
                    <c:v>8.493131344815881</c:v>
                  </c:pt>
                  <c:pt idx="2">
                    <c:v>14.39360996091442</c:v>
                  </c:pt>
                  <c:pt idx="3">
                    <c:v>11.47025221074641</c:v>
                  </c:pt>
                  <c:pt idx="4">
                    <c:v>8.431870490434218</c:v>
                  </c:pt>
                  <c:pt idx="5">
                    <c:v>0.567894273258425</c:v>
                  </c:pt>
                </c:numCache>
              </c:numRef>
            </c:minus>
          </c:errBars>
          <c:xVal>
            <c:numRef>
              <c:f>KIDNEY!$B$89:$B$94</c:f>
              <c:numCache>
                <c:formatCode>General</c:formatCode>
                <c:ptCount val="6"/>
                <c:pt idx="0">
                  <c:v>0.0833333333333333</c:v>
                </c:pt>
                <c:pt idx="1">
                  <c:v>0.25</c:v>
                </c:pt>
                <c:pt idx="2">
                  <c:v>0.5</c:v>
                </c:pt>
                <c:pt idx="3">
                  <c:v>1.0</c:v>
                </c:pt>
                <c:pt idx="4">
                  <c:v>3.0</c:v>
                </c:pt>
                <c:pt idx="5">
                  <c:v>8.0</c:v>
                </c:pt>
              </c:numCache>
            </c:numRef>
          </c:xVal>
          <c:yVal>
            <c:numRef>
              <c:f>KIDNEY!$C$89:$C$94</c:f>
              <c:numCache>
                <c:formatCode>General</c:formatCode>
                <c:ptCount val="6"/>
                <c:pt idx="0">
                  <c:v>76.95505731907725</c:v>
                </c:pt>
                <c:pt idx="1">
                  <c:v>80.15550728011678</c:v>
                </c:pt>
                <c:pt idx="2">
                  <c:v>78.88415493673561</c:v>
                </c:pt>
                <c:pt idx="3">
                  <c:v>48.49673052556131</c:v>
                </c:pt>
                <c:pt idx="4">
                  <c:v>19.67043264882475</c:v>
                </c:pt>
                <c:pt idx="5">
                  <c:v>1.88493592396144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57426936"/>
        <c:axId val="-2084408616"/>
      </c:scatterChart>
      <c:valAx>
        <c:axId val="-2057426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84408616"/>
        <c:crosses val="autoZero"/>
        <c:crossBetween val="midCat"/>
      </c:valAx>
      <c:valAx>
        <c:axId val="-2084408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zh-CN"/>
            </a:pPr>
            <a:endParaRPr lang="zh-CN"/>
          </a:p>
        </c:txPr>
        <c:crossAx val="-205742693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>
            <p:extLst>
              <p:ext uri="{D42A27DB-BD31-4B8C-83A1-F6EECF244321}">
                <p14:modId xmlns:p14="http://schemas.microsoft.com/office/powerpoint/2010/main" val="1047477479"/>
              </p:ext>
            </p:extLst>
          </p:nvPr>
        </p:nvGraphicFramePr>
        <p:xfrm>
          <a:off x="827584" y="692696"/>
          <a:ext cx="2304256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/>
          <p:nvPr>
            <p:extLst>
              <p:ext uri="{D42A27DB-BD31-4B8C-83A1-F6EECF244321}">
                <p14:modId xmlns:p14="http://schemas.microsoft.com/office/powerpoint/2010/main" val="3947459137"/>
              </p:ext>
            </p:extLst>
          </p:nvPr>
        </p:nvGraphicFramePr>
        <p:xfrm>
          <a:off x="3275856" y="692696"/>
          <a:ext cx="2291716" cy="1926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图表 5"/>
          <p:cNvGraphicFramePr/>
          <p:nvPr>
            <p:extLst>
              <p:ext uri="{D42A27DB-BD31-4B8C-83A1-F6EECF244321}">
                <p14:modId xmlns:p14="http://schemas.microsoft.com/office/powerpoint/2010/main" val="3878977844"/>
              </p:ext>
            </p:extLst>
          </p:nvPr>
        </p:nvGraphicFramePr>
        <p:xfrm>
          <a:off x="5796136" y="620688"/>
          <a:ext cx="2664296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图表 6"/>
          <p:cNvGraphicFramePr/>
          <p:nvPr>
            <p:extLst>
              <p:ext uri="{D42A27DB-BD31-4B8C-83A1-F6EECF244321}">
                <p14:modId xmlns:p14="http://schemas.microsoft.com/office/powerpoint/2010/main" val="394560074"/>
              </p:ext>
            </p:extLst>
          </p:nvPr>
        </p:nvGraphicFramePr>
        <p:xfrm>
          <a:off x="827584" y="3068960"/>
          <a:ext cx="2339752" cy="2163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图表 7"/>
          <p:cNvGraphicFramePr/>
          <p:nvPr>
            <p:extLst>
              <p:ext uri="{D42A27DB-BD31-4B8C-83A1-F6EECF244321}">
                <p14:modId xmlns:p14="http://schemas.microsoft.com/office/powerpoint/2010/main" val="1848424437"/>
              </p:ext>
            </p:extLst>
          </p:nvPr>
        </p:nvGraphicFramePr>
        <p:xfrm>
          <a:off x="3347864" y="3284984"/>
          <a:ext cx="2436302" cy="1876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图表 8"/>
          <p:cNvGraphicFramePr/>
          <p:nvPr>
            <p:extLst>
              <p:ext uri="{D42A27DB-BD31-4B8C-83A1-F6EECF244321}">
                <p14:modId xmlns:p14="http://schemas.microsoft.com/office/powerpoint/2010/main" val="3090366735"/>
              </p:ext>
            </p:extLst>
          </p:nvPr>
        </p:nvGraphicFramePr>
        <p:xfrm>
          <a:off x="6012160" y="3284984"/>
          <a:ext cx="2232248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" name="文本框 19"/>
          <p:cNvSpPr txBox="1"/>
          <p:nvPr/>
        </p:nvSpPr>
        <p:spPr>
          <a:xfrm>
            <a:off x="1331640" y="2492896"/>
            <a:ext cx="600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hours</a:t>
            </a:r>
            <a:endParaRPr kumimoji="1"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3995936" y="2492896"/>
            <a:ext cx="600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hours</a:t>
            </a:r>
            <a:endParaRPr kumimoji="1"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6660232" y="2492896"/>
            <a:ext cx="600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hours</a:t>
            </a:r>
            <a:endParaRPr kumimoji="1"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547664" y="5085184"/>
            <a:ext cx="600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hours</a:t>
            </a:r>
            <a:endParaRPr kumimoji="1"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4067944" y="5085184"/>
            <a:ext cx="600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hours</a:t>
            </a:r>
            <a:endParaRPr kumimoji="1"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6732240" y="5085184"/>
            <a:ext cx="600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hours</a:t>
            </a:r>
            <a:endParaRPr kumimoji="1"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 flipV="1">
            <a:off x="467544" y="836712"/>
            <a:ext cx="400110" cy="122413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smtClean="0"/>
              <a:t>Sunitinib</a:t>
            </a:r>
            <a:r>
              <a:rPr lang="zh-CN" altLang="en-US" sz="1400" dirty="0" smtClean="0"/>
              <a:t> </a:t>
            </a:r>
            <a:r>
              <a:rPr lang="en-US" altLang="zh-CN" sz="1400" dirty="0" err="1"/>
              <a:t>ng</a:t>
            </a:r>
            <a:r>
              <a:rPr lang="en-US" altLang="zh-CN" sz="1400" dirty="0"/>
              <a:t>/</a:t>
            </a:r>
            <a:r>
              <a:rPr lang="en-US" altLang="zh-CN" sz="1400" dirty="0" smtClean="0"/>
              <a:t>ml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 flipV="1">
            <a:off x="467544" y="3356992"/>
            <a:ext cx="400110" cy="122413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smtClean="0"/>
              <a:t>Sunitinib</a:t>
            </a:r>
            <a:r>
              <a:rPr lang="zh-CN" altLang="en-US" sz="1400" dirty="0" smtClean="0"/>
              <a:t> </a:t>
            </a:r>
            <a:r>
              <a:rPr lang="en-US" altLang="zh-CN" sz="1400" dirty="0" err="1"/>
              <a:t>ng</a:t>
            </a:r>
            <a:r>
              <a:rPr lang="en-US" altLang="zh-CN" sz="1400" dirty="0"/>
              <a:t>/</a:t>
            </a:r>
            <a:r>
              <a:rPr lang="en-US" altLang="zh-CN" sz="1400" dirty="0" smtClean="0"/>
              <a:t>ml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 flipV="1">
            <a:off x="2915816" y="980728"/>
            <a:ext cx="400110" cy="122413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smtClean="0"/>
              <a:t>Sunitinib</a:t>
            </a:r>
            <a:r>
              <a:rPr lang="zh-CN" altLang="en-US" sz="1400" dirty="0" smtClean="0"/>
              <a:t> </a:t>
            </a:r>
            <a:r>
              <a:rPr lang="en-US" altLang="zh-CN" sz="1400" dirty="0" err="1"/>
              <a:t>ng</a:t>
            </a:r>
            <a:r>
              <a:rPr lang="en-US" altLang="zh-CN" sz="1400" dirty="0"/>
              <a:t>/</a:t>
            </a:r>
            <a:r>
              <a:rPr lang="en-US" altLang="zh-CN" sz="1400" dirty="0" smtClean="0"/>
              <a:t>ml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 flipV="1">
            <a:off x="5580112" y="908720"/>
            <a:ext cx="400110" cy="122413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smtClean="0"/>
              <a:t>Sunitinib</a:t>
            </a:r>
            <a:r>
              <a:rPr lang="zh-CN" altLang="en-US" sz="1400" dirty="0" smtClean="0"/>
              <a:t> </a:t>
            </a:r>
            <a:r>
              <a:rPr lang="en-US" altLang="zh-CN" sz="1400" dirty="0" err="1"/>
              <a:t>ng</a:t>
            </a:r>
            <a:r>
              <a:rPr lang="en-US" altLang="zh-CN" sz="1400" dirty="0"/>
              <a:t>/</a:t>
            </a:r>
            <a:r>
              <a:rPr lang="en-US" altLang="zh-CN" sz="1400" dirty="0" smtClean="0"/>
              <a:t>ml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 flipV="1">
            <a:off x="5580112" y="3429000"/>
            <a:ext cx="400110" cy="122413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smtClean="0"/>
              <a:t>Sunitinib</a:t>
            </a:r>
            <a:r>
              <a:rPr lang="zh-CN" altLang="en-US" sz="1400" dirty="0" smtClean="0"/>
              <a:t> </a:t>
            </a:r>
            <a:r>
              <a:rPr lang="en-US" altLang="zh-CN" sz="1400" dirty="0" err="1"/>
              <a:t>ng</a:t>
            </a:r>
            <a:r>
              <a:rPr lang="en-US" altLang="zh-CN" sz="1400" dirty="0"/>
              <a:t>/</a:t>
            </a:r>
            <a:r>
              <a:rPr lang="en-US" altLang="zh-CN" sz="1400" dirty="0" smtClean="0"/>
              <a:t>ml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 flipV="1">
            <a:off x="2987824" y="3573016"/>
            <a:ext cx="400110" cy="122413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dirty="0" smtClean="0"/>
              <a:t>Sunitinib</a:t>
            </a:r>
            <a:r>
              <a:rPr lang="zh-CN" altLang="en-US" sz="1400" dirty="0" smtClean="0"/>
              <a:t> </a:t>
            </a:r>
            <a:r>
              <a:rPr lang="en-US" altLang="zh-CN" sz="1400" dirty="0" err="1"/>
              <a:t>ng</a:t>
            </a:r>
            <a:r>
              <a:rPr lang="en-US" altLang="zh-CN" sz="1400" dirty="0"/>
              <a:t>/</a:t>
            </a:r>
            <a:r>
              <a:rPr lang="en-US" altLang="zh-CN" sz="1400" dirty="0" smtClean="0"/>
              <a:t>ml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>
            <a:off x="1187624" y="332656"/>
            <a:ext cx="5367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a                                            </a:t>
            </a:r>
            <a:r>
              <a:rPr kumimoji="1" lang="en-US" altLang="zh-CN" dirty="0" err="1" smtClean="0"/>
              <a:t>b</a:t>
            </a:r>
            <a:r>
              <a:rPr kumimoji="1" lang="en-US" altLang="zh-CN" dirty="0" smtClean="0"/>
              <a:t>                                                 c</a:t>
            </a:r>
            <a:endParaRPr kumimoji="1" lang="zh-CN" altLang="en-US" dirty="0"/>
          </a:p>
        </p:txBody>
      </p:sp>
      <p:sp>
        <p:nvSpPr>
          <p:cNvPr id="35" name="文本框 34"/>
          <p:cNvSpPr txBox="1"/>
          <p:nvPr/>
        </p:nvSpPr>
        <p:spPr>
          <a:xfrm>
            <a:off x="1403648" y="2852936"/>
            <a:ext cx="5301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err="1"/>
              <a:t>d</a:t>
            </a:r>
            <a:r>
              <a:rPr kumimoji="1" lang="en-US" altLang="zh-CN" dirty="0" smtClean="0"/>
              <a:t>                                           </a:t>
            </a:r>
            <a:r>
              <a:rPr kumimoji="1" lang="en-US" altLang="zh-CN" dirty="0" err="1"/>
              <a:t>e</a:t>
            </a:r>
            <a:r>
              <a:rPr kumimoji="1" lang="en-US" altLang="zh-CN" dirty="0" smtClean="0"/>
              <a:t>                                                 </a:t>
            </a:r>
            <a:r>
              <a:rPr kumimoji="1" lang="en-US" altLang="zh-CN" dirty="0"/>
              <a:t>f</a:t>
            </a:r>
            <a:endParaRPr kumimoji="1" lang="zh-CN" altLang="en-US" dirty="0"/>
          </a:p>
        </p:txBody>
      </p:sp>
      <p:sp>
        <p:nvSpPr>
          <p:cNvPr id="32" name="TextBox 16"/>
          <p:cNvSpPr txBox="1"/>
          <p:nvPr/>
        </p:nvSpPr>
        <p:spPr>
          <a:xfrm>
            <a:off x="0" y="35024"/>
            <a:ext cx="7848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Supplementary Figure 1. 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</TotalTime>
  <Words>40</Words>
  <Application>Microsoft Macintosh PowerPoint</Application>
  <PresentationFormat>全屏显示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静脉给药Sample A 和Sunitinib后舒尼替尼在小鼠血浆及各脏器中分布的对比</dc:title>
  <dc:creator>Administrator</dc:creator>
  <cp:lastModifiedBy>apple</cp:lastModifiedBy>
  <cp:revision>35</cp:revision>
  <dcterms:created xsi:type="dcterms:W3CDTF">2015-04-30T18:18:05Z</dcterms:created>
  <dcterms:modified xsi:type="dcterms:W3CDTF">2015-10-14T04:53:03Z</dcterms:modified>
</cp:coreProperties>
</file>